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5" d="100"/>
          <a:sy n="95" d="100"/>
        </p:scale>
        <p:origin x="-1188" y="18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0158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43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9135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9671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9218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191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949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6473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3920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1534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34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CA85F-9FAD-4E8C-8FB9-D53BD3B2DD80}" type="datetimeFigureOut">
              <a:rPr lang="en-US" smtClean="0"/>
              <a:t>11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01BBB7-0DFA-449A-A314-5A25740EF3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194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9.png"/><Relationship Id="rId18" Type="http://schemas.microsoft.com/office/2007/relationships/hdphoto" Target="../media/hdphoto5.wdp"/><Relationship Id="rId3" Type="http://schemas.openxmlformats.org/officeDocument/2006/relationships/image" Target="../media/image2.png"/><Relationship Id="rId21" Type="http://schemas.microsoft.com/office/2007/relationships/hdphoto" Target="../media/hdphoto6.wdp"/><Relationship Id="rId7" Type="http://schemas.openxmlformats.org/officeDocument/2006/relationships/image" Target="../media/image5.png"/><Relationship Id="rId12" Type="http://schemas.microsoft.com/office/2007/relationships/hdphoto" Target="../media/hdphoto3.wdp"/><Relationship Id="rId17" Type="http://schemas.openxmlformats.org/officeDocument/2006/relationships/image" Target="../media/image12.png"/><Relationship Id="rId2" Type="http://schemas.openxmlformats.org/officeDocument/2006/relationships/image" Target="../media/image1.png"/><Relationship Id="rId16" Type="http://schemas.openxmlformats.org/officeDocument/2006/relationships/image" Target="../media/image11.png"/><Relationship Id="rId20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5" Type="http://schemas.microsoft.com/office/2007/relationships/hdphoto" Target="../media/hdphoto4.wdp"/><Relationship Id="rId10" Type="http://schemas.openxmlformats.org/officeDocument/2006/relationships/image" Target="../media/image7.png"/><Relationship Id="rId19" Type="http://schemas.openxmlformats.org/officeDocument/2006/relationships/image" Target="../media/image13.png"/><Relationship Id="rId4" Type="http://schemas.microsoft.com/office/2007/relationships/hdphoto" Target="../media/hdphoto1.wdp"/><Relationship Id="rId9" Type="http://schemas.microsoft.com/office/2007/relationships/hdphoto" Target="../media/hdphoto2.wdp"/><Relationship Id="rId14" Type="http://schemas.openxmlformats.org/officeDocument/2006/relationships/image" Target="../media/image10.png"/><Relationship Id="rId22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21607" y="7284432"/>
            <a:ext cx="3333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000" dirty="0" smtClean="0">
                <a:latin typeface="Arial" pitchFamily="34" charset="0"/>
                <a:cs typeface="Arial" pitchFamily="34" charset="0"/>
              </a:rPr>
              <a:t>wt</a:t>
            </a:r>
            <a:endParaRPr lang="sv-SE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6" name="Picture 4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-1" r="55777" b="-213"/>
          <a:stretch/>
        </p:blipFill>
        <p:spPr bwMode="auto">
          <a:xfrm>
            <a:off x="120561" y="270046"/>
            <a:ext cx="972000" cy="180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3" cstate="print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8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5708" y="428681"/>
            <a:ext cx="971368" cy="8476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AutoShape 149"/>
          <p:cNvSpPr>
            <a:spLocks noChangeArrowheads="1"/>
          </p:cNvSpPr>
          <p:nvPr/>
        </p:nvSpPr>
        <p:spPr bwMode="auto">
          <a:xfrm>
            <a:off x="2305233" y="304800"/>
            <a:ext cx="971368" cy="77425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269927" y="626615"/>
            <a:ext cx="9375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270837" y="857249"/>
            <a:ext cx="13868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NH</a:t>
            </a:r>
            <a:r>
              <a:rPr lang="sv-SE" sz="800" b="1" baseline="-25000" dirty="0" smtClean="0">
                <a:latin typeface="Arial" pitchFamily="34" charset="0"/>
                <a:cs typeface="Arial" pitchFamily="34" charset="0"/>
              </a:rPr>
              <a:t>4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Cl (250nM)+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61312" y="1066799"/>
            <a:ext cx="13678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NH</a:t>
            </a:r>
            <a:r>
              <a:rPr lang="sv-SE" sz="800" b="1" baseline="-25000" dirty="0" smtClean="0">
                <a:latin typeface="Arial" pitchFamily="34" charset="0"/>
                <a:cs typeface="Arial" pitchFamily="34" charset="0"/>
              </a:rPr>
              <a:t>4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Cl (500nM)+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Phleo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5" cstate="print">
            <a:grayscl/>
            <a:lum bright="-22000" contrast="18000"/>
          </a:blip>
          <a:srcRect/>
          <a:stretch>
            <a:fillRect/>
          </a:stretch>
        </p:blipFill>
        <p:spPr bwMode="auto">
          <a:xfrm>
            <a:off x="4707004" y="392720"/>
            <a:ext cx="969896" cy="106460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TextBox 12"/>
          <p:cNvSpPr txBox="1"/>
          <p:nvPr/>
        </p:nvSpPr>
        <p:spPr>
          <a:xfrm>
            <a:off x="5646221" y="395771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655746" y="614846"/>
            <a:ext cx="10117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1 mM CdCl</a:t>
            </a:r>
            <a:r>
              <a:rPr lang="sv-SE" sz="800" b="1" baseline="-25000" dirty="0" smtClean="0">
                <a:latin typeface="Arial" pitchFamily="34" charset="0"/>
                <a:cs typeface="Arial" pitchFamily="34" charset="0"/>
              </a:rPr>
              <a:t>2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646221" y="819149"/>
            <a:ext cx="11355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1 mM CdCl</a:t>
            </a:r>
            <a:r>
              <a:rPr lang="sv-SE" sz="800" b="1" baseline="-250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K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665271" y="1043471"/>
            <a:ext cx="10117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2 mM CdCl</a:t>
            </a:r>
            <a:r>
              <a:rPr lang="sv-SE" sz="800" b="1" baseline="-25000" dirty="0" smtClean="0">
                <a:latin typeface="Arial" pitchFamily="34" charset="0"/>
                <a:cs typeface="Arial" pitchFamily="34" charset="0"/>
              </a:rPr>
              <a:t>2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646221" y="1262546"/>
            <a:ext cx="12879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2 mM CdCl</a:t>
            </a:r>
            <a:r>
              <a:rPr lang="sv-SE" sz="800" b="1" baseline="-250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K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8" name="Picture 10"/>
          <p:cNvPicPr>
            <a:picLocks noChangeAspect="1" noChangeArrowheads="1"/>
          </p:cNvPicPr>
          <p:nvPr/>
        </p:nvPicPr>
        <p:blipFill>
          <a:blip r:embed="rId6" cstate="print">
            <a:lum bright="-15000" contrast="-12000"/>
          </a:blip>
          <a:srcRect/>
          <a:stretch>
            <a:fillRect/>
          </a:stretch>
        </p:blipFill>
        <p:spPr bwMode="auto">
          <a:xfrm>
            <a:off x="150879" y="2505684"/>
            <a:ext cx="982596" cy="1056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" name="TextBox 18"/>
          <p:cNvSpPr txBox="1"/>
          <p:nvPr/>
        </p:nvSpPr>
        <p:spPr>
          <a:xfrm>
            <a:off x="1126674" y="2500796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126674" y="2700821"/>
            <a:ext cx="10117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1mM 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dCl</a:t>
            </a:r>
            <a:r>
              <a:rPr lang="sv-SE" sz="800" b="1" baseline="-25000" dirty="0" smtClean="0">
                <a:latin typeface="Arial" pitchFamily="34" charset="0"/>
                <a:cs typeface="Arial" pitchFamily="34" charset="0"/>
              </a:rPr>
              <a:t>2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126674" y="2919896"/>
            <a:ext cx="13546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1mM 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dCl</a:t>
            </a:r>
            <a:r>
              <a:rPr lang="sv-SE" sz="800" b="1" baseline="-250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Na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126674" y="3129446"/>
            <a:ext cx="10117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2mM 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dCl</a:t>
            </a:r>
            <a:r>
              <a:rPr lang="sv-SE" sz="800" b="1" baseline="-25000" dirty="0" smtClean="0">
                <a:latin typeface="Arial" pitchFamily="34" charset="0"/>
                <a:cs typeface="Arial" pitchFamily="34" charset="0"/>
              </a:rPr>
              <a:t>2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26674" y="3338996"/>
            <a:ext cx="14118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2mM 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dCl</a:t>
            </a:r>
            <a:r>
              <a:rPr lang="sv-SE" sz="800" b="1" baseline="-250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NaCl</a:t>
            </a:r>
            <a:endParaRPr lang="sv-SE" sz="800" b="1" baseline="-25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4" name="Picture 2"/>
          <p:cNvPicPr>
            <a:picLocks noChangeAspect="1" noChangeArrowheads="1"/>
          </p:cNvPicPr>
          <p:nvPr/>
        </p:nvPicPr>
        <p:blipFill>
          <a:blip r:embed="rId7" cstate="print">
            <a:grayscl/>
            <a:lum bright="-20000" contrast="22000"/>
          </a:blip>
          <a:srcRect/>
          <a:stretch>
            <a:fillRect/>
          </a:stretch>
        </p:blipFill>
        <p:spPr bwMode="auto">
          <a:xfrm>
            <a:off x="165087" y="4103325"/>
            <a:ext cx="977914" cy="7618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5" name="TextBox 24"/>
          <p:cNvSpPr txBox="1"/>
          <p:nvPr/>
        </p:nvSpPr>
        <p:spPr>
          <a:xfrm>
            <a:off x="1121256" y="4127694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121256" y="4352925"/>
            <a:ext cx="10123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0.4% Acetic acid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1121256" y="4629150"/>
            <a:ext cx="12695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0.4% Acetic acid+ 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060127" y="416213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060127" y="625763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0.6M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Rb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060127" y="845690"/>
            <a:ext cx="9375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060127" y="1055240"/>
            <a:ext cx="12068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 0.038M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060127" y="1236215"/>
            <a:ext cx="12068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 0.075M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060127" y="1445765"/>
            <a:ext cx="12068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 0.150M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060127" y="1645790"/>
            <a:ext cx="12068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 0.300M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060127" y="1826765"/>
            <a:ext cx="12068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 0.600M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AutoShape 149"/>
          <p:cNvSpPr>
            <a:spLocks noChangeArrowheads="1"/>
          </p:cNvSpPr>
          <p:nvPr/>
        </p:nvSpPr>
        <p:spPr bwMode="auto">
          <a:xfrm>
            <a:off x="4707004" y="266700"/>
            <a:ext cx="971368" cy="77425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AutoShape 149"/>
          <p:cNvSpPr>
            <a:spLocks noChangeArrowheads="1"/>
          </p:cNvSpPr>
          <p:nvPr/>
        </p:nvSpPr>
        <p:spPr bwMode="auto">
          <a:xfrm>
            <a:off x="150879" y="2381250"/>
            <a:ext cx="971368" cy="77425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0" y="0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A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009775" y="19050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B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467225" y="0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C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0" y="2121644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D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869877" y="3543300"/>
            <a:ext cx="60674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3533775" y="3543300"/>
            <a:ext cx="71437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098603" y="3543300"/>
            <a:ext cx="103537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 </a:t>
            </a:r>
          </a:p>
          <a:p>
            <a:pPr algn="ctr"/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0.6M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898703" y="3543300"/>
            <a:ext cx="1035372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</a:t>
            </a:r>
          </a:p>
          <a:p>
            <a:pPr algn="ctr"/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0.6M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Na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715000" y="3543300"/>
            <a:ext cx="914400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</a:t>
            </a:r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+</a:t>
            </a:r>
          </a:p>
          <a:p>
            <a:pPr algn="ctr"/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 0.6M </a:t>
            </a:r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Rb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8" name="Picture 2"/>
          <p:cNvPicPr>
            <a:picLocks noChangeAspect="1" noChangeArrowheads="1"/>
          </p:cNvPicPr>
          <p:nvPr/>
        </p:nvPicPr>
        <p:blipFill>
          <a:blip r:embed="rId8" cstate="print">
            <a:grayscl/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3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8918" y="5457110"/>
            <a:ext cx="1203197" cy="21612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AutoShape 149"/>
          <p:cNvSpPr>
            <a:spLocks noChangeArrowheads="1"/>
          </p:cNvSpPr>
          <p:nvPr/>
        </p:nvSpPr>
        <p:spPr bwMode="auto">
          <a:xfrm>
            <a:off x="128918" y="5316367"/>
            <a:ext cx="1162050" cy="95250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318200" y="5460985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318200" y="5724524"/>
            <a:ext cx="16023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mycin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sv-SE" sz="800" b="1">
                <a:latin typeface="Arial" pitchFamily="34" charset="0"/>
                <a:cs typeface="Arial" pitchFamily="34" charset="0"/>
              </a:rPr>
              <a:t>1</a:t>
            </a:r>
            <a:r>
              <a:rPr lang="sv-SE" sz="800" b="1" smtClean="0">
                <a:latin typeface="Arial" pitchFamily="34" charset="0"/>
                <a:cs typeface="Arial" pitchFamily="34" charset="0"/>
              </a:rPr>
              <a:t>0 </a:t>
            </a:r>
            <a:r>
              <a:rPr lang="sv-SE" sz="800" b="1" smtClean="0">
                <a:latin typeface="Arial" pitchFamily="34" charset="0"/>
                <a:cs typeface="Arial" pitchFamily="34" charset="0"/>
              </a:rPr>
              <a:t>µg/m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318200" y="6002179"/>
            <a:ext cx="11905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0.2% Acetic acid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1318200" y="6259354"/>
            <a:ext cx="1715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mycin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+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Acetic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acid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318200" y="6515142"/>
            <a:ext cx="24537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mycin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+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Acetic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acid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0.6M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318200" y="6843872"/>
            <a:ext cx="12287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0.4%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Lactic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acid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318200" y="7114336"/>
            <a:ext cx="171588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mycin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+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Lactic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acid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318200" y="7372171"/>
            <a:ext cx="20967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itchFamily="34" charset="0"/>
              </a:rPr>
              <a:t>Phleomycin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+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Lactic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acid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8" name="AutoShape 149"/>
          <p:cNvSpPr>
            <a:spLocks noChangeArrowheads="1"/>
          </p:cNvSpPr>
          <p:nvPr/>
        </p:nvSpPr>
        <p:spPr bwMode="auto">
          <a:xfrm>
            <a:off x="162108" y="3981450"/>
            <a:ext cx="971368" cy="77425"/>
          </a:xfrm>
          <a:prstGeom prst="rtTriangle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sv-SE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114550" y="1454894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E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0" y="3750419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F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0" y="5112494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>
                <a:latin typeface="Arial" pitchFamily="34" charset="0"/>
                <a:cs typeface="Arial" pitchFamily="34" charset="0"/>
              </a:rPr>
              <a:t>G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0" y="7846205"/>
            <a:ext cx="11811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sv-SE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le</a:t>
            </a:r>
            <a:r>
              <a:rPr lang="sv-S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264971" y="424346"/>
            <a:ext cx="76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anose="020B0604020202020204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 rot="16200000">
            <a:off x="1795949" y="2519003"/>
            <a:ext cx="10996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bsorbance OD</a:t>
            </a:r>
            <a:r>
              <a:rPr lang="en-US" sz="8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r>
              <a:rPr lang="en-US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pic>
        <p:nvPicPr>
          <p:cNvPr id="74" name="Picture 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5808" y="4572835"/>
            <a:ext cx="862479" cy="7463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5" name="Picture 3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30000" contrast="7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85808" y="5344520"/>
            <a:ext cx="861726" cy="7463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6" name="Picture 4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9647" y="4572835"/>
            <a:ext cx="861726" cy="74635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7" name="Picture 5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30000" contrast="7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79647" y="5344520"/>
            <a:ext cx="861726" cy="7427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8" name="Picture 6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9160" y="4572000"/>
            <a:ext cx="861239" cy="7479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9" name="Picture 7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30000" contrast="7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9160" y="5344520"/>
            <a:ext cx="861568" cy="7480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0" name="Picture 8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5441" y="4573623"/>
            <a:ext cx="862159" cy="7462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1" name="Picture 9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30000" contrast="7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57240" y="5344520"/>
            <a:ext cx="865889" cy="750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2" name="TextBox 81"/>
          <p:cNvSpPr txBox="1"/>
          <p:nvPr/>
        </p:nvSpPr>
        <p:spPr>
          <a:xfrm>
            <a:off x="3098931" y="4367302"/>
            <a:ext cx="5501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3961891" y="4367302"/>
            <a:ext cx="8792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Doxorubicin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4868607" y="4244192"/>
            <a:ext cx="8530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Doxorubicin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KC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5745369" y="4244192"/>
            <a:ext cx="86530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Doxorubicin</a:t>
            </a:r>
            <a:r>
              <a:rPr lang="sv-SE" sz="800" b="1" dirty="0" smtClean="0">
                <a:latin typeface="Arial" pitchFamily="34" charset="0"/>
                <a:cs typeface="Arial" pitchFamily="34" charset="0"/>
              </a:rPr>
              <a:t>+ </a:t>
            </a:r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Sorbitol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 rot="16200000">
            <a:off x="2558719" y="5610687"/>
            <a:ext cx="840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err="1" smtClean="0">
                <a:latin typeface="Arial" pitchFamily="34" charset="0"/>
                <a:cs typeface="Arial" pitchFamily="34" charset="0"/>
              </a:rPr>
              <a:t>Doxorubicin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7" name="Straight Connector 86"/>
          <p:cNvCxnSpPr/>
          <p:nvPr/>
        </p:nvCxnSpPr>
        <p:spPr>
          <a:xfrm flipV="1">
            <a:off x="3771204" y="5273277"/>
            <a:ext cx="62407" cy="9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 rot="16200000">
            <a:off x="2558719" y="4857154"/>
            <a:ext cx="8402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DIC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648277" y="4298398"/>
            <a:ext cx="2987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800" b="1" dirty="0" smtClean="0">
                <a:latin typeface="Arial" pitchFamily="34" charset="0"/>
                <a:cs typeface="Arial" pitchFamily="34" charset="0"/>
              </a:rPr>
              <a:t>H</a:t>
            </a:r>
            <a:endParaRPr lang="sv-SE" sz="8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0888" y="1547664"/>
            <a:ext cx="4285786" cy="1972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07110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</TotalTime>
  <Words>145</Words>
  <Application>Microsoft Office PowerPoint</Application>
  <PresentationFormat>On-screen Show (4:3)</PresentationFormat>
  <Paragraphs>5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othenburg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Patrick Alao</dc:creator>
  <cp:lastModifiedBy>John Patrick Alao</cp:lastModifiedBy>
  <cp:revision>8</cp:revision>
  <dcterms:created xsi:type="dcterms:W3CDTF">2014-10-05T12:05:39Z</dcterms:created>
  <dcterms:modified xsi:type="dcterms:W3CDTF">2014-11-22T20:36:27Z</dcterms:modified>
</cp:coreProperties>
</file>